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7" r:id="rId2"/>
    <p:sldId id="31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588" autoAdjust="0"/>
    <p:restoredTop sz="94624" autoAdjust="0"/>
  </p:normalViewPr>
  <p:slideViewPr>
    <p:cSldViewPr>
      <p:cViewPr>
        <p:scale>
          <a:sx n="60" d="100"/>
          <a:sy n="60" d="100"/>
        </p:scale>
        <p:origin x="-1572" y="-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1CC08-2541-4D03-A5F5-E6A6145BDA8D}" type="datetimeFigureOut">
              <a:rPr lang="en-US" smtClean="0"/>
              <a:pPr/>
              <a:t>3/13/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A6B8D9-3F5B-4FC7-A9BB-729952CB9838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96255" y="373742"/>
            <a:ext cx="8719145" cy="5417458"/>
            <a:chOff x="196255" y="373742"/>
            <a:chExt cx="8719145" cy="4884058"/>
          </a:xfrm>
        </p:grpSpPr>
        <p:pic>
          <p:nvPicPr>
            <p:cNvPr id="3090" name="Picture 18" descr="C:\Users\DELL\Desktop\Picture1.pn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96255" y="373742"/>
              <a:ext cx="2170113" cy="2444750"/>
            </a:xfrm>
            <a:prstGeom prst="rect">
              <a:avLst/>
            </a:prstGeom>
            <a:noFill/>
          </p:spPr>
        </p:pic>
        <p:pic>
          <p:nvPicPr>
            <p:cNvPr id="3093" name="Picture 21" descr="C:\Users\DELL\Desktop\Picture2.png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392407" y="386246"/>
              <a:ext cx="2170113" cy="2408237"/>
            </a:xfrm>
            <a:prstGeom prst="rect">
              <a:avLst/>
            </a:prstGeom>
            <a:noFill/>
          </p:spPr>
        </p:pic>
        <p:pic>
          <p:nvPicPr>
            <p:cNvPr id="3094" name="Picture 22" descr="C:\Users\DELL\Desktop\Picture3.png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567033" y="373742"/>
              <a:ext cx="2170113" cy="2425700"/>
            </a:xfrm>
            <a:prstGeom prst="rect">
              <a:avLst/>
            </a:prstGeom>
            <a:noFill/>
          </p:spPr>
        </p:pic>
        <p:pic>
          <p:nvPicPr>
            <p:cNvPr id="3095" name="Picture 23" descr="C:\Users\DELL\Desktop\Picture4.png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735563" y="376609"/>
              <a:ext cx="2170113" cy="2408237"/>
            </a:xfrm>
            <a:prstGeom prst="rect">
              <a:avLst/>
            </a:prstGeom>
            <a:noFill/>
          </p:spPr>
        </p:pic>
        <p:pic>
          <p:nvPicPr>
            <p:cNvPr id="3096" name="Picture 24" descr="C:\Users\DELL\Desktop\Picture5.png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10004" y="2819400"/>
              <a:ext cx="2170113" cy="2438400"/>
            </a:xfrm>
            <a:prstGeom prst="rect">
              <a:avLst/>
            </a:prstGeom>
            <a:noFill/>
          </p:spPr>
        </p:pic>
        <p:pic>
          <p:nvPicPr>
            <p:cNvPr id="3097" name="Picture 25" descr="C:\Users\DELL\Desktop\Picture6.png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376487" y="2795808"/>
              <a:ext cx="2170113" cy="2438400"/>
            </a:xfrm>
            <a:prstGeom prst="rect">
              <a:avLst/>
            </a:prstGeom>
            <a:noFill/>
          </p:spPr>
        </p:pic>
        <p:pic>
          <p:nvPicPr>
            <p:cNvPr id="3098" name="Picture 26" descr="C:\Users\DELL\Desktop\Picture7.png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4560887" y="2799442"/>
              <a:ext cx="2170113" cy="2425700"/>
            </a:xfrm>
            <a:prstGeom prst="rect">
              <a:avLst/>
            </a:prstGeom>
            <a:noFill/>
          </p:spPr>
        </p:pic>
        <p:pic>
          <p:nvPicPr>
            <p:cNvPr id="3099" name="Picture 27" descr="C:\Users\DELL\Desktop\Picture8.png"/>
            <p:cNvPicPr>
              <a:picLocks noChangeAspect="1"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6745287" y="2785917"/>
              <a:ext cx="2170113" cy="2455863"/>
            </a:xfrm>
            <a:prstGeom prst="rect">
              <a:avLst/>
            </a:prstGeom>
            <a:noFill/>
          </p:spPr>
        </p:pic>
      </p:grpSp>
      <p:sp>
        <p:nvSpPr>
          <p:cNvPr id="11" name="TextBox 10"/>
          <p:cNvSpPr txBox="1"/>
          <p:nvPr/>
        </p:nvSpPr>
        <p:spPr>
          <a:xfrm>
            <a:off x="685800" y="6183868"/>
            <a:ext cx="777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membran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domains for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NH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/NHE proteins.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3"/>
          <p:cNvGrpSpPr/>
          <p:nvPr/>
        </p:nvGrpSpPr>
        <p:grpSpPr>
          <a:xfrm>
            <a:off x="152007" y="115494"/>
            <a:ext cx="8808061" cy="6164438"/>
            <a:chOff x="107339" y="83962"/>
            <a:chExt cx="8852729" cy="6640034"/>
          </a:xfrm>
        </p:grpSpPr>
        <p:pic>
          <p:nvPicPr>
            <p:cNvPr id="3074" name="Picture 2" descr="C:\Users\DELL\Desktop\Picture1.png"/>
            <p:cNvPicPr preferRelativeResize="0">
              <a:picLocks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09969" y="83962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75" name="Picture 3" descr="C:\Users\DELL\Desktop\Picture7.png"/>
            <p:cNvPicPr preferRelativeResize="0">
              <a:picLocks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4574237" y="2320034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76" name="Picture 4" descr="C:\Users\DELL\Desktop\Picture6.png"/>
            <p:cNvPicPr preferRelativeResize="0">
              <a:picLocks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2351301" y="2320034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77" name="Picture 5" descr="C:\Users\DELL\Desktop\Picture5.png"/>
            <p:cNvPicPr preferRelativeResize="0"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123105" y="2317404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78" name="Picture 6" descr="C:\Users\DELL\Desktop\Picture4.png"/>
            <p:cNvPicPr preferRelativeResize="0">
              <a:picLocks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6800068" y="83962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79" name="Picture 7" descr="C:\Users\DELL\Desktop\Picture3.png"/>
            <p:cNvPicPr preferRelativeResize="0"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571607" y="83962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0" name="Picture 8" descr="C:\Users\DELL\Desktop\Picture2.png"/>
            <p:cNvPicPr preferRelativeResize="0">
              <a:picLocks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2338037" y="83962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1" name="Picture 9" descr="C:\Users\DELL\Desktop\Picture12.png"/>
            <p:cNvPicPr preferRelativeResize="0">
              <a:picLocks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6799803" y="4563996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2" name="Picture 10" descr="C:\Users\DELL\Desktop\Picture11.png"/>
            <p:cNvPicPr preferRelativeResize="0">
              <a:picLocks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4574237" y="4553362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3" name="Picture 11" descr="C:\Users\DELL\Desktop\Picture10.png"/>
            <p:cNvPicPr preferRelativeResize="0">
              <a:picLocks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2335535" y="4550860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4" name="Picture 12" descr="C:\Users\DELL\Desktop\Picture9.png"/>
            <p:cNvPicPr preferRelativeResize="0">
              <a:picLocks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107339" y="4561366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  <p:pic>
          <p:nvPicPr>
            <p:cNvPr id="3085" name="Picture 13" descr="C:\Users\DELL\Desktop\Picture8.png"/>
            <p:cNvPicPr preferRelativeResize="0">
              <a:picLocks noChangeArrowheads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6799803" y="2309528"/>
              <a:ext cx="2160000" cy="2160000"/>
            </a:xfrm>
            <a:prstGeom prst="rect">
              <a:avLst/>
            </a:prstGeom>
            <a:noFill/>
            <a:ln w="19050" cmpd="sng">
              <a:solidFill>
                <a:schemeClr val="tx2"/>
              </a:solidFill>
            </a:ln>
          </p:spPr>
        </p:pic>
      </p:grpSp>
      <p:sp>
        <p:nvSpPr>
          <p:cNvPr id="15" name="TextBox 14"/>
          <p:cNvSpPr txBox="1"/>
          <p:nvPr/>
        </p:nvSpPr>
        <p:spPr>
          <a:xfrm>
            <a:off x="685800" y="6412468"/>
            <a:ext cx="792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tring analysis for individual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NHX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/NHE proteins.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36</TotalTime>
  <Words>19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DELL</cp:lastModifiedBy>
  <cp:revision>346</cp:revision>
  <dcterms:created xsi:type="dcterms:W3CDTF">2006-08-16T00:00:00Z</dcterms:created>
  <dcterms:modified xsi:type="dcterms:W3CDTF">2018-03-13T13:55:23Z</dcterms:modified>
</cp:coreProperties>
</file>